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9" autoAdjust="0"/>
    <p:restoredTop sz="94660"/>
  </p:normalViewPr>
  <p:slideViewPr>
    <p:cSldViewPr snapToGrid="0">
      <p:cViewPr varScale="1">
        <p:scale>
          <a:sx n="152" d="100"/>
          <a:sy n="152" d="100"/>
        </p:scale>
        <p:origin x="576" y="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86C890-FF04-435D-AFEC-A17B357D6E9D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FA68FB-5A35-4EE2-BC3E-A32DD17BBA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5409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1E8EE7-3D61-A346-8D62-2AB4989596E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70070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3AD6F8-8C28-D380-12A1-63C58E5EA5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6CAEBD8-944C-760D-0701-938D94690EB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6FD3B6-E220-5B61-BFE8-11311CB277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8D0C2-AFA6-4E2D-8528-AB0157D88206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DB1DB9-E2ED-305E-FB98-4BAA3D9AFA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582A24-3906-06A1-9E3D-3C3775D3EA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287ED-C01F-48E1-AAC4-4B633D6377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596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F2A700-8694-1C88-20B4-F252B4645D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3EDBE45-D500-38CA-B599-73E3FCACBC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9432D2-CBAA-2D32-CD11-BEF5F902DB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8D0C2-AFA6-4E2D-8528-AB0157D88206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1F4829-90C0-DB6B-6D52-BAD2D10B1C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56BCC5-A6DA-1149-C85C-94FEBC8DD4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287ED-C01F-48E1-AAC4-4B633D6377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76189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5A79FD9-14B8-1B1F-D26B-27299A2CBD3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91F511-3AA6-92EC-8D1B-6C170DD0A3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904A72-B9AE-D7AF-8E77-ADF52270A0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8D0C2-AFA6-4E2D-8528-AB0157D88206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8E3924-0F3A-8798-81D9-A68C3207B4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F36D8B-3AF7-F714-5659-0F2505C8B7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287ED-C01F-48E1-AAC4-4B633D6377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6C99EE-7BC3-CEC2-C9F6-D0ABD38E08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D0A17C-91A5-961F-E298-D982AB75940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E8316C-98A7-96E3-D337-698BBE7596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8D0C2-AFA6-4E2D-8528-AB0157D88206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649AD3-57A5-45FD-8C89-4AC57AA019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ADB855-E937-352B-CCA3-994BAEBEEE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287ED-C01F-48E1-AAC4-4B633D6377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19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59F700-2B22-0228-3634-C6E8D6B71A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1AE122-D7DF-86AF-A8BA-2631E4631F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4D2303-09F0-EFFF-3797-235F37FD11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8D0C2-AFA6-4E2D-8528-AB0157D88206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6EE68B-4B48-3D8E-2582-1D8921FB5F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F3249F-6FE5-CA7E-A76A-4CB9CD7F81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287ED-C01F-48E1-AAC4-4B633D6377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92556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A3A675-C712-876B-8625-20080D2AAF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2CE808-1FBD-8146-F526-D2942981ACA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06C7F59-AC27-A416-F5F9-CAE0D3F3D4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9FED68-A9BA-8087-99C4-2DA420DA53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8D0C2-AFA6-4E2D-8528-AB0157D88206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3CF0F2-5662-00E2-2D12-3E66243640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8F410A-9267-4CC8-B9B1-8A93A65551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287ED-C01F-48E1-AAC4-4B633D6377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78224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33244D-7C1A-0C48-6973-F34846BFE3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02EA36-D06B-3716-D202-89D1F12608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6A23B1-6808-6AB8-0F11-AC2476DACC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59052A0-81CA-B564-4606-E9EA50116F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DE11409-0954-9E1A-9DB1-9F7FD5E594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0A2888A-3FA1-3317-B63E-F055ECEDF1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8D0C2-AFA6-4E2D-8528-AB0157D88206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600C0BB-BE31-146C-D1E4-8491EC95E8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AF46886-44CF-3372-4C27-6A1B43128C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287ED-C01F-48E1-AAC4-4B633D6377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92394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020358-B9CD-A7C2-9101-CD7AC6C75D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07AA794-0526-3056-50DC-DB623636E1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8D0C2-AFA6-4E2D-8528-AB0157D88206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F125E5A-DF56-E35C-2D40-76E79BE444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0C3C831-3A81-42CC-FF90-6E89D087F3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287ED-C01F-48E1-AAC4-4B633D6377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25801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07AAB6D-81B5-6F19-8165-59141791E4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8D0C2-AFA6-4E2D-8528-AB0157D88206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4F025C0-2F53-1FFB-7F49-5047BC545E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52E4991-1FF2-536C-A629-DE6412EA5F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287ED-C01F-48E1-AAC4-4B633D6377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6444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563B2E-731C-4482-4073-73238812AC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88B378-4BCA-3A9D-3E27-221F4E8E5B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CF19556-FCFD-9E90-A7B1-111BCC8C10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4023B4-1568-BF94-D968-03E92C3588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8D0C2-AFA6-4E2D-8528-AB0157D88206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5BE692-3FA0-A7F5-1336-117F0190F9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8AD85E-21B6-E1A4-1308-40BBB60A0E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287ED-C01F-48E1-AAC4-4B633D6377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1487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0AFB96-E3A0-925D-8887-3F907F7FB2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CADDB20-CE0F-0A82-0ED3-FB67C3FD402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FD3B115-A0D7-B799-1EFE-F0361E4174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788AB0-9F25-F0BD-4A3F-41D5333BC5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8D0C2-AFA6-4E2D-8528-AB0157D88206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45FCFB-3922-FE89-77E1-06EFD25D0D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630F3C-F4CA-569A-A331-6DE52FCDED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287ED-C01F-48E1-AAC4-4B633D6377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932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923178F-8A9F-415C-2C50-C05AFC7B63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2AF14D-4F96-6A45-0163-5AF61CA00A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62E052-9824-AFBA-7143-1794113F470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E78D0C2-AFA6-4E2D-8528-AB0157D88206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B7C10D-6FF7-9B69-1770-A3D3BC0597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E8F46B-3630-6A1E-5CBC-6069EDC2D5F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C2287ED-C01F-48E1-AAC4-4B633D6377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4536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Group 48">
            <a:extLst>
              <a:ext uri="{FF2B5EF4-FFF2-40B4-BE49-F238E27FC236}">
                <a16:creationId xmlns:a16="http://schemas.microsoft.com/office/drawing/2014/main" id="{9730C881-D161-DB02-37FA-D7C2883D73F3}"/>
              </a:ext>
            </a:extLst>
          </p:cNvPr>
          <p:cNvGrpSpPr/>
          <p:nvPr/>
        </p:nvGrpSpPr>
        <p:grpSpPr>
          <a:xfrm>
            <a:off x="1936629" y="992409"/>
            <a:ext cx="8203306" cy="5142877"/>
            <a:chOff x="1781433" y="442930"/>
            <a:chExt cx="8203306" cy="5142877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C768AA3-1F29-CB84-5B69-0DBF2E9BBD0B}"/>
                </a:ext>
              </a:extLst>
            </p:cNvPr>
            <p:cNvSpPr txBox="1"/>
            <p:nvPr/>
          </p:nvSpPr>
          <p:spPr>
            <a:xfrm>
              <a:off x="4895921" y="442930"/>
              <a:ext cx="2016852" cy="86177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sz="1000" b="0" i="0" u="none" strike="noStrike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"BMC Neurology"[Journal] OR "J Med Case Rep"[Journal] OR "Medicine (Baltimore)"[Journal]) AND "case report"[Title] AND "Stroke"[</a:t>
              </a:r>
              <a:r>
                <a:rPr lang="en-US" sz="1000" b="0" i="0" u="none" strike="noStrike" err="1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eSH</a:t>
              </a:r>
              <a:r>
                <a:rPr lang="en-US" sz="1000" b="0" i="0" u="none" strike="noStrike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erms]</a:t>
              </a:r>
              <a:endParaRPr lang="en-US" sz="100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CC6E0B2-A100-F2CD-61A7-86ECDB4232AA}"/>
                </a:ext>
              </a:extLst>
            </p:cNvPr>
            <p:cNvSpPr txBox="1"/>
            <p:nvPr/>
          </p:nvSpPr>
          <p:spPr>
            <a:xfrm>
              <a:off x="2084341" y="442930"/>
              <a:ext cx="2118569" cy="86177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sz="1000" b="0" i="0" u="none" strike="noStrike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"BMC Neurology"[Journal] OR "J Med Case Rep"[Journal] OR "Medicine (Baltimore)"[Journal]) AND "case report"[Title] AND "Headache"[</a:t>
              </a:r>
              <a:r>
                <a:rPr lang="en-US" sz="1000" b="0" i="0" u="none" strike="noStrike" err="1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eSH</a:t>
              </a:r>
              <a:r>
                <a:rPr lang="en-US" sz="1000" b="0" i="0" u="none" strike="noStrike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erms]</a:t>
              </a:r>
              <a:endParaRPr lang="en-US" sz="100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33CAFF4-387B-7321-6CFA-1D4CB18BE21E}"/>
                </a:ext>
              </a:extLst>
            </p:cNvPr>
            <p:cNvSpPr txBox="1"/>
            <p:nvPr/>
          </p:nvSpPr>
          <p:spPr>
            <a:xfrm>
              <a:off x="7679504" y="442930"/>
              <a:ext cx="2016852" cy="116955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sz="1000" b="0" i="0" u="none" strike="noStrike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"BMC Neurology"[Journal] OR "J Med Case Rep"[Journal] OR "Medicine (Baltimore)"[Journal]) AND "case report"[Title] AND "dementia"[</a:t>
              </a:r>
              <a:r>
                <a:rPr lang="en-US" sz="1000" b="0" i="0" u="none" strike="noStrike" err="1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eSH</a:t>
              </a:r>
              <a:r>
                <a:rPr lang="en-US" sz="1000" b="0" i="0" u="none" strike="noStrike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erms] OR "Parkinson Disease"[</a:t>
              </a:r>
              <a:r>
                <a:rPr lang="en-US" sz="1000" b="0" i="0" u="none" strike="noStrike" err="1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eSH</a:t>
              </a:r>
              <a:r>
                <a:rPr lang="en-US" sz="1000" b="0" i="0" u="none" strike="noStrike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erms]</a:t>
              </a:r>
              <a:endParaRPr lang="en-US" sz="100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4CA359A-C473-9E09-58D3-84EDD7128C34}"/>
                </a:ext>
              </a:extLst>
            </p:cNvPr>
            <p:cNvSpPr txBox="1"/>
            <p:nvPr/>
          </p:nvSpPr>
          <p:spPr>
            <a:xfrm>
              <a:off x="5225322" y="1835731"/>
              <a:ext cx="1358048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sz="1000" b="0" i="0" u="none" strike="noStrike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83 ‘Stroke’ cases from </a:t>
              </a:r>
              <a:r>
                <a:rPr lang="en-US" sz="1000" b="0" i="1" u="none" strike="noStrike" err="1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ubMedCentral</a:t>
              </a:r>
              <a:endParaRPr lang="en-US" sz="1000" i="1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09CD08D-2FC5-B6CA-2A32-94A44C5389DE}"/>
                </a:ext>
              </a:extLst>
            </p:cNvPr>
            <p:cNvSpPr txBox="1"/>
            <p:nvPr/>
          </p:nvSpPr>
          <p:spPr>
            <a:xfrm>
              <a:off x="2422374" y="1835731"/>
              <a:ext cx="1442502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sz="1000" b="0" i="0" u="none" strike="noStrike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2 ‘Headache’ cases from </a:t>
              </a:r>
              <a:r>
                <a:rPr lang="en-US" sz="1000" b="0" i="1" u="none" strike="noStrike" err="1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ubMedCentral</a:t>
              </a:r>
              <a:endParaRPr lang="en-US" sz="1000" i="1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8D98ADE-CEF0-4068-A8E0-F436C94618A6}"/>
                </a:ext>
              </a:extLst>
            </p:cNvPr>
            <p:cNvSpPr txBox="1"/>
            <p:nvPr/>
          </p:nvSpPr>
          <p:spPr>
            <a:xfrm>
              <a:off x="7937781" y="1835731"/>
              <a:ext cx="1500297" cy="55399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sz="1000" b="0" i="0" u="none" strike="noStrike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6 ‘Neurodegenerative disease’ cases from </a:t>
              </a:r>
              <a:r>
                <a:rPr lang="en-US" sz="1000" b="0" i="1" u="none" strike="noStrike" err="1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ubMedCentral</a:t>
              </a:r>
              <a:endParaRPr lang="en-US" sz="1000" i="1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C2CFB28-2988-F57A-177D-20C191FA4F11}"/>
                </a:ext>
              </a:extLst>
            </p:cNvPr>
            <p:cNvSpPr txBox="1"/>
            <p:nvPr/>
          </p:nvSpPr>
          <p:spPr>
            <a:xfrm>
              <a:off x="1781433" y="2589957"/>
              <a:ext cx="2657984" cy="147732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000">
                  <a:latin typeface="Arial" panose="020B0604020202020204" pitchFamily="34" charset="0"/>
                  <a:cs typeface="Arial" panose="020B0604020202020204" pitchFamily="34" charset="0"/>
                </a:rPr>
                <a:t>96 excluded</a:t>
              </a:r>
            </a:p>
            <a:p>
              <a:r>
                <a:rPr lang="en-US" sz="1000" b="0" i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 treatment failures or complications</a:t>
              </a:r>
              <a:endParaRPr lang="en-US" sz="1000" b="0" i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000" b="0" i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4 insufficient or confusing clinical description to generate a clinical diagnosis</a:t>
              </a:r>
              <a:endParaRPr lang="en-US" sz="10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000" b="0" i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 non-neurological conditions or non-neurological</a:t>
              </a:r>
              <a:r>
                <a:rPr lang="en-US" sz="1000" b="0" i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symptoms</a:t>
              </a:r>
            </a:p>
            <a:p>
              <a:r>
                <a:rPr lang="en-US" sz="1000" b="0" i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9 more than one neurological condition coexisting </a:t>
              </a:r>
            </a:p>
            <a:p>
              <a:r>
                <a:rPr lang="en-US" sz="100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 duplicate diagnoses</a:t>
              </a:r>
              <a:endParaRPr lang="en-US" sz="1000" b="0" i="0">
                <a:solidFill>
                  <a:srgbClr val="0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DF8A99D-629F-AE50-8668-F4AE7B409F6D}"/>
                </a:ext>
              </a:extLst>
            </p:cNvPr>
            <p:cNvSpPr txBox="1"/>
            <p:nvPr/>
          </p:nvSpPr>
          <p:spPr>
            <a:xfrm>
              <a:off x="7391120" y="2589957"/>
              <a:ext cx="2593619" cy="147732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000">
                  <a:latin typeface="Arial" panose="020B0604020202020204" pitchFamily="34" charset="0"/>
                  <a:cs typeface="Arial" panose="020B0604020202020204" pitchFamily="34" charset="0"/>
                </a:rPr>
                <a:t>81 excluded</a:t>
              </a:r>
            </a:p>
            <a:p>
              <a:r>
                <a:rPr lang="en-US" sz="1000" b="0" i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1 treatment failures or complications</a:t>
              </a:r>
              <a:endParaRPr lang="en-US" sz="1000" b="0" i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000" b="0" i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1 insufficient or confusing clinical description to generate a clinical diagnosis</a:t>
              </a:r>
              <a:endParaRPr lang="en-US" sz="10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000" b="0" i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 non-neurological conditions or non-neurological</a:t>
              </a:r>
              <a:r>
                <a:rPr lang="en-US" sz="1000" b="0" i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symptoms</a:t>
              </a:r>
            </a:p>
            <a:p>
              <a:r>
                <a:rPr lang="en-US" sz="1000" b="0" i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5 more than one neurological condition coexisting </a:t>
              </a:r>
            </a:p>
            <a:p>
              <a:r>
                <a:rPr lang="en-US" sz="100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 duplicate diagnoses</a:t>
              </a:r>
              <a:endParaRPr lang="en-US" sz="1000" b="0" i="0">
                <a:solidFill>
                  <a:srgbClr val="0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CBF6199-E199-58AD-38C0-FD95B767A7F9}"/>
                </a:ext>
              </a:extLst>
            </p:cNvPr>
            <p:cNvSpPr txBox="1"/>
            <p:nvPr/>
          </p:nvSpPr>
          <p:spPr>
            <a:xfrm>
              <a:off x="4607534" y="2592291"/>
              <a:ext cx="2593116" cy="132343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000">
                  <a:latin typeface="Arial" panose="020B0604020202020204" pitchFamily="34" charset="0"/>
                  <a:cs typeface="Arial" panose="020B0604020202020204" pitchFamily="34" charset="0"/>
                </a:rPr>
                <a:t>259 excluded</a:t>
              </a:r>
            </a:p>
            <a:p>
              <a:r>
                <a:rPr lang="en-US" sz="1000" b="0" i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 treatment failures or complications</a:t>
              </a:r>
              <a:endParaRPr lang="en-US" sz="1000" b="0" i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000" b="0" i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4 insufficient or confusing clinical description to generate a clinical diagnosis</a:t>
              </a:r>
              <a:endParaRPr lang="en-US" sz="10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000" b="0" i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4 non-neurological conditions or non-neurological</a:t>
              </a:r>
              <a:r>
                <a:rPr lang="en-US" sz="1000" b="0" i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symptoms</a:t>
              </a:r>
            </a:p>
            <a:p>
              <a:r>
                <a:rPr lang="en-US" sz="1000" b="0" i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1 more than one neurological condition coexisting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12867BD-DE7E-2C10-DE4A-9BB6AF9F2162}"/>
                </a:ext>
              </a:extLst>
            </p:cNvPr>
            <p:cNvSpPr txBox="1"/>
            <p:nvPr/>
          </p:nvSpPr>
          <p:spPr>
            <a:xfrm>
              <a:off x="5225324" y="4322253"/>
              <a:ext cx="1358048" cy="2462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</a:rPr>
                <a:t>24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‘Stroke’ cases</a:t>
              </a:r>
              <a:endParaRPr lang="en-US" sz="1000" i="1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1618DECE-8994-64B1-A011-415D371F3C46}"/>
                </a:ext>
              </a:extLst>
            </p:cNvPr>
            <p:cNvSpPr txBox="1"/>
            <p:nvPr/>
          </p:nvSpPr>
          <p:spPr>
            <a:xfrm>
              <a:off x="2431401" y="4323750"/>
              <a:ext cx="1358048" cy="2462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  <a:latin typeface="Arial" panose="020B0604020202020204" pitchFamily="34" charset="0"/>
                </a:rPr>
                <a:t>6</a:t>
              </a:r>
              <a:r>
                <a:rPr lang="en-US" sz="1000" b="0" i="0" u="none" strike="noStrike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‘Headache’ cases</a:t>
              </a:r>
              <a:endParaRPr lang="en-US" sz="1000" i="1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BE6E1FC-EE10-2E88-2DE5-1CDF21506A1F}"/>
                </a:ext>
              </a:extLst>
            </p:cNvPr>
            <p:cNvSpPr txBox="1"/>
            <p:nvPr/>
          </p:nvSpPr>
          <p:spPr>
            <a:xfrm>
              <a:off x="7905731" y="5185697"/>
              <a:ext cx="1532347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  <a:latin typeface="Arial" panose="020B0604020202020204" pitchFamily="34" charset="0"/>
                </a:rPr>
                <a:t>5</a:t>
              </a:r>
              <a:r>
                <a:rPr lang="en-US" sz="1000" b="0" i="0" u="none" strike="noStrike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‘Neurodegenerative disease’ cases</a:t>
              </a:r>
              <a:endParaRPr lang="en-US" sz="1000" i="1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D3BE3D91-9C08-051A-B4AE-8783EEF7C9A5}"/>
                </a:ext>
              </a:extLst>
            </p:cNvPr>
            <p:cNvSpPr txBox="1"/>
            <p:nvPr/>
          </p:nvSpPr>
          <p:spPr>
            <a:xfrm>
              <a:off x="2364702" y="4754724"/>
              <a:ext cx="4180150" cy="2462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>
                  <a:solidFill>
                    <a:srgbClr val="000000"/>
                  </a:solidFill>
                  <a:latin typeface="Arial" panose="020B0604020202020204" pitchFamily="34" charset="0"/>
                </a:rPr>
                <a:t>Randomized selection of 5 cases</a:t>
              </a:r>
              <a:endParaRPr lang="en-US" sz="1000" i="1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D7BB781B-9701-F0C5-CFF8-7671B6C7F943}"/>
                </a:ext>
              </a:extLst>
            </p:cNvPr>
            <p:cNvSpPr txBox="1"/>
            <p:nvPr/>
          </p:nvSpPr>
          <p:spPr>
            <a:xfrm>
              <a:off x="2464602" y="5185697"/>
              <a:ext cx="1358048" cy="2462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  <a:latin typeface="Arial" panose="020B0604020202020204" pitchFamily="34" charset="0"/>
                </a:rPr>
                <a:t>5</a:t>
              </a:r>
              <a:r>
                <a:rPr lang="en-US" sz="1000" b="0" i="0" u="none" strike="noStrike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‘Headache’ cases</a:t>
              </a:r>
              <a:endParaRPr lang="en-US" sz="1000" i="1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A529704-985D-81EC-9C48-7E317D827628}"/>
                </a:ext>
              </a:extLst>
            </p:cNvPr>
            <p:cNvSpPr txBox="1"/>
            <p:nvPr/>
          </p:nvSpPr>
          <p:spPr>
            <a:xfrm>
              <a:off x="5225322" y="5185697"/>
              <a:ext cx="1358048" cy="2462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  <a:latin typeface="Arial" panose="020B0604020202020204" pitchFamily="34" charset="0"/>
                </a:rPr>
                <a:t>5</a:t>
              </a:r>
              <a:r>
                <a:rPr lang="en-US" sz="1000" b="0" i="0" u="none" strike="noStrike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‘Stroke’ cases</a:t>
              </a:r>
              <a:endParaRPr lang="en-US" sz="1000" i="1"/>
            </a:p>
          </p:txBody>
        </p: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73BD3E53-288A-28B0-80F3-54FD05E62C22}"/>
                </a:ext>
              </a:extLst>
            </p:cNvPr>
            <p:cNvCxnSpPr>
              <a:stCxn id="6" idx="2"/>
              <a:endCxn id="9" idx="0"/>
            </p:cNvCxnSpPr>
            <p:nvPr/>
          </p:nvCxnSpPr>
          <p:spPr>
            <a:xfrm flipH="1">
              <a:off x="5904346" y="1304704"/>
              <a:ext cx="1" cy="531027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CBED2799-9FFA-C73D-1C84-D71A69711293}"/>
                </a:ext>
              </a:extLst>
            </p:cNvPr>
            <p:cNvCxnSpPr/>
            <p:nvPr/>
          </p:nvCxnSpPr>
          <p:spPr>
            <a:xfrm flipH="1">
              <a:off x="3143624" y="1298309"/>
              <a:ext cx="1" cy="531027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E6FFB4EA-DEB9-868B-B97B-D5549A2ADD65}"/>
                </a:ext>
              </a:extLst>
            </p:cNvPr>
            <p:cNvCxnSpPr>
              <a:cxnSpLocks/>
              <a:endCxn id="11" idx="0"/>
            </p:cNvCxnSpPr>
            <p:nvPr/>
          </p:nvCxnSpPr>
          <p:spPr>
            <a:xfrm>
              <a:off x="8687929" y="1612481"/>
              <a:ext cx="1" cy="22325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9DDFF107-21D2-00F5-9C22-3E7595A4073B}"/>
                </a:ext>
              </a:extLst>
            </p:cNvPr>
            <p:cNvCxnSpPr>
              <a:cxnSpLocks/>
              <a:endCxn id="17" idx="0"/>
            </p:cNvCxnSpPr>
            <p:nvPr/>
          </p:nvCxnSpPr>
          <p:spPr>
            <a:xfrm flipH="1">
              <a:off x="5904092" y="2238175"/>
              <a:ext cx="250" cy="354116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4A82A163-3F46-BA2C-8160-E7E659B0A40F}"/>
                </a:ext>
              </a:extLst>
            </p:cNvPr>
            <p:cNvCxnSpPr>
              <a:cxnSpLocks/>
            </p:cNvCxnSpPr>
            <p:nvPr/>
          </p:nvCxnSpPr>
          <p:spPr>
            <a:xfrm>
              <a:off x="3143623" y="2235841"/>
              <a:ext cx="1" cy="354116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38EF3678-54BB-95AD-03B5-17865D181897}"/>
                </a:ext>
              </a:extLst>
            </p:cNvPr>
            <p:cNvCxnSpPr>
              <a:cxnSpLocks/>
              <a:endCxn id="16" idx="0"/>
            </p:cNvCxnSpPr>
            <p:nvPr/>
          </p:nvCxnSpPr>
          <p:spPr>
            <a:xfrm>
              <a:off x="8687926" y="2383402"/>
              <a:ext cx="4" cy="206555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50FA4B57-69E2-E13A-C807-89969AEEDBF0}"/>
                </a:ext>
              </a:extLst>
            </p:cNvPr>
            <p:cNvCxnSpPr>
              <a:cxnSpLocks/>
              <a:stCxn id="17" idx="2"/>
              <a:endCxn id="18" idx="0"/>
            </p:cNvCxnSpPr>
            <p:nvPr/>
          </p:nvCxnSpPr>
          <p:spPr>
            <a:xfrm>
              <a:off x="5904092" y="3915730"/>
              <a:ext cx="256" cy="406523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2B395962-4646-3CA8-82E4-01AB25A0A090}"/>
                </a:ext>
              </a:extLst>
            </p:cNvPr>
            <p:cNvCxnSpPr>
              <a:cxnSpLocks/>
              <a:stCxn id="12" idx="2"/>
              <a:endCxn id="19" idx="0"/>
            </p:cNvCxnSpPr>
            <p:nvPr/>
          </p:nvCxnSpPr>
          <p:spPr>
            <a:xfrm>
              <a:off x="3110425" y="4067285"/>
              <a:ext cx="0" cy="256465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E0A0F89C-A5F4-EC8A-7585-85D68D8466D5}"/>
                </a:ext>
              </a:extLst>
            </p:cNvPr>
            <p:cNvCxnSpPr>
              <a:cxnSpLocks/>
              <a:stCxn id="16" idx="2"/>
              <a:endCxn id="20" idx="0"/>
            </p:cNvCxnSpPr>
            <p:nvPr/>
          </p:nvCxnSpPr>
          <p:spPr>
            <a:xfrm flipH="1">
              <a:off x="8671905" y="4067285"/>
              <a:ext cx="16025" cy="1118412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D83EC985-1749-5981-8CC0-59164C5FBF5C}"/>
                </a:ext>
              </a:extLst>
            </p:cNvPr>
            <p:cNvCxnSpPr>
              <a:cxnSpLocks/>
            </p:cNvCxnSpPr>
            <p:nvPr/>
          </p:nvCxnSpPr>
          <p:spPr>
            <a:xfrm>
              <a:off x="5904345" y="4562147"/>
              <a:ext cx="1" cy="191079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C9BB1E55-0B2C-AE55-701E-19C3984BF582}"/>
                </a:ext>
              </a:extLst>
            </p:cNvPr>
            <p:cNvCxnSpPr>
              <a:cxnSpLocks/>
            </p:cNvCxnSpPr>
            <p:nvPr/>
          </p:nvCxnSpPr>
          <p:spPr>
            <a:xfrm>
              <a:off x="3100811" y="4569971"/>
              <a:ext cx="1" cy="191079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150F4520-106D-9C6C-3018-7F8694D40FAC}"/>
                </a:ext>
              </a:extLst>
            </p:cNvPr>
            <p:cNvCxnSpPr>
              <a:cxnSpLocks/>
            </p:cNvCxnSpPr>
            <p:nvPr/>
          </p:nvCxnSpPr>
          <p:spPr>
            <a:xfrm>
              <a:off x="5904345" y="4999323"/>
              <a:ext cx="1" cy="191079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7E9F41D1-583F-97F7-5B45-858AC18CF181}"/>
                </a:ext>
              </a:extLst>
            </p:cNvPr>
            <p:cNvCxnSpPr>
              <a:cxnSpLocks/>
            </p:cNvCxnSpPr>
            <p:nvPr/>
          </p:nvCxnSpPr>
          <p:spPr>
            <a:xfrm>
              <a:off x="3100810" y="4994618"/>
              <a:ext cx="1" cy="191079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1EBAF535-4FD6-A401-0C20-55894E017797}"/>
              </a:ext>
            </a:extLst>
          </p:cNvPr>
          <p:cNvSpPr txBox="1"/>
          <p:nvPr/>
        </p:nvSpPr>
        <p:spPr>
          <a:xfrm>
            <a:off x="1664167" y="338297"/>
            <a:ext cx="609669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 err="1">
                <a:effectLst/>
                <a:latin typeface="Arial" panose="020B0604020202020204" pitchFamily="34" charset="0"/>
                <a:ea typeface="Malgun Gothic" panose="020B0503020000020004" pitchFamily="34" charset="-127"/>
              </a:rPr>
              <a:t>e</a:t>
            </a:r>
            <a:r>
              <a:rPr lang="en-US" sz="1000" b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e</a:t>
            </a:r>
            <a:r>
              <a:rPr lang="en-US" sz="10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1.</a:t>
            </a:r>
            <a:r>
              <a:rPr lang="en-US" sz="1000" b="1" dirty="0">
                <a:effectLst/>
                <a:latin typeface="Arial" panose="020B0604020202020204" pitchFamily="34" charset="0"/>
                <a:ea typeface="Malgun Gothic" panose="020B0503020000020004" pitchFamily="34" charset="-127"/>
              </a:rPr>
              <a:t> Case report acquisition and categorization.</a:t>
            </a:r>
            <a:endParaRPr 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17060257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1</Words>
  <Application>Microsoft Office PowerPoint</Application>
  <PresentationFormat>Widescreen</PresentationFormat>
  <Paragraphs>3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ng-Hyun Lee</dc:creator>
  <cp:lastModifiedBy>Jung-Hyun Lee</cp:lastModifiedBy>
  <cp:revision>1</cp:revision>
  <dcterms:created xsi:type="dcterms:W3CDTF">2024-05-10T00:10:46Z</dcterms:created>
  <dcterms:modified xsi:type="dcterms:W3CDTF">2024-05-10T00:11:04Z</dcterms:modified>
</cp:coreProperties>
</file>